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6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0116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9497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84591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4093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35533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4939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5944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1267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2438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1292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3551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135C3-89EA-4770-8D9B-E511953A4E2F}" type="datetimeFigureOut">
              <a:rPr lang="en-IN" smtClean="0"/>
              <a:t>20-0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BCBC45-B0DB-4291-978E-AC3CF07E531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23734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606583" y="581118"/>
            <a:ext cx="7551721" cy="5548880"/>
            <a:chOff x="244445" y="390996"/>
            <a:chExt cx="7551721" cy="554888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230" t="17513" r="10260" b="24869"/>
            <a:stretch/>
          </p:blipFill>
          <p:spPr>
            <a:xfrm>
              <a:off x="244445" y="390996"/>
              <a:ext cx="3739080" cy="2596648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/>
            <a:srcRect l="10539" t="18075" r="10525" b="24916"/>
            <a:stretch/>
          </p:blipFill>
          <p:spPr>
            <a:xfrm>
              <a:off x="4200809" y="390997"/>
              <a:ext cx="3595357" cy="259664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/>
            <a:srcRect l="10209" t="17615" r="9921" b="24321"/>
            <a:stretch/>
          </p:blipFill>
          <p:spPr>
            <a:xfrm>
              <a:off x="244445" y="3267735"/>
              <a:ext cx="3739081" cy="267214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/>
            <a:srcRect l="10525" t="17103" r="9757" b="24035"/>
            <a:stretch/>
          </p:blipFill>
          <p:spPr>
            <a:xfrm>
              <a:off x="4177273" y="3267735"/>
              <a:ext cx="3618893" cy="2672141"/>
            </a:xfrm>
            <a:prstGeom prst="rect">
              <a:avLst/>
            </a:prstGeom>
          </p:spPr>
        </p:pic>
      </p:grpSp>
      <p:sp>
        <p:nvSpPr>
          <p:cNvPr id="3" name="TextBox 2"/>
          <p:cNvSpPr txBox="1"/>
          <p:nvPr/>
        </p:nvSpPr>
        <p:spPr>
          <a:xfrm>
            <a:off x="262795" y="6129998"/>
            <a:ext cx="86003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. Fig. </a:t>
            </a:r>
            <a:r>
              <a:rPr lang="en-US" b="1" dirty="0" smtClean="0"/>
              <a:t>S17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Venn diagrams showing common genes (up-regulated and down-regulated)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between tuber and leaf tissues of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Kufri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Jyoti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Kufri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Pukhraj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.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6503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2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9</cp:revision>
  <dcterms:created xsi:type="dcterms:W3CDTF">2025-01-10T10:22:31Z</dcterms:created>
  <dcterms:modified xsi:type="dcterms:W3CDTF">2025-02-20T03:54:12Z</dcterms:modified>
</cp:coreProperties>
</file>